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6">
          <p15:clr>
            <a:srgbClr val="A4A3A4"/>
          </p15:clr>
        </p15:guide>
        <p15:guide id="2" pos="324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37"/>
  </p:normalViewPr>
  <p:slideViewPr>
    <p:cSldViewPr showGuides="1">
      <p:cViewPr>
        <p:scale>
          <a:sx n="125" d="100"/>
          <a:sy n="125" d="100"/>
        </p:scale>
        <p:origin x="-864" y="520"/>
      </p:cViewPr>
      <p:guideLst>
        <p:guide orient="horz" pos="2886"/>
        <p:guide pos="324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slide" Target="slides/slide22.xml"/><Relationship Id="rId24" Type="http://schemas.openxmlformats.org/officeDocument/2006/relationships/slide" Target="slides/slide23.xml"/><Relationship Id="rId25" Type="http://schemas.openxmlformats.org/officeDocument/2006/relationships/slide" Target="slides/slide24.xml"/><Relationship Id="rId26" Type="http://schemas.openxmlformats.org/officeDocument/2006/relationships/slide" Target="slides/slide25.xml"/><Relationship Id="rId27" Type="http://schemas.openxmlformats.org/officeDocument/2006/relationships/printerSettings" Target="printerSettings/printerSettings1.bin"/><Relationship Id="rId28" Type="http://schemas.openxmlformats.org/officeDocument/2006/relationships/presProps" Target="presProps.xml"/><Relationship Id="rId29" Type="http://schemas.openxmlformats.org/officeDocument/2006/relationships/viewProps" Target="viewProps.xml"/><Relationship Id="rId30" Type="http://schemas.openxmlformats.org/officeDocument/2006/relationships/theme" Target="theme/theme1.xml"/><Relationship Id="rId31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239AE-2F54-46CB-8EF5-D05667D8F5FD}" type="datetimeFigureOut">
              <a:rPr kumimoji="1" lang="ja-JP" altLang="en-US" smtClean="0"/>
              <a:pPr/>
              <a:t>21/04/27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D3C0E1-BF0D-4B23-82F8-61DB8E2A4EA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9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0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1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2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5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6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7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19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0.png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1.png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2.png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3.png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kumimoji="1" lang="en-US" altLang="ja-JP" dirty="0"/>
              <a:t>Traveled Distance</a:t>
            </a:r>
            <a:endParaRPr kumimoji="1" lang="ja-JP" alt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199_nogreenlineall.png"/>
          <p:cNvPicPr>
            <a:picLocks noChangeAspect="1"/>
          </p:cNvPicPr>
          <p:nvPr/>
        </p:nvPicPr>
        <p:blipFill rotWithShape="1">
          <a:blip r:embed="rId2"/>
          <a:srcRect t="14246" r="7219" b="11880"/>
          <a:stretch/>
        </p:blipFill>
        <p:spPr>
          <a:xfrm>
            <a:off x="0" y="1459042"/>
            <a:ext cx="9144000" cy="5066302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30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-34957" y="3106735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142844" y="3071810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142844" y="278605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3786190"/>
            <a:ext cx="621510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378619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197_nogreenlineall.png"/>
          <p:cNvPicPr>
            <a:picLocks noChangeAspect="1"/>
          </p:cNvPicPr>
          <p:nvPr/>
        </p:nvPicPr>
        <p:blipFill rotWithShape="1">
          <a:blip r:embed="rId2"/>
          <a:srcRect t="14042" r="7219" b="23276"/>
          <a:stretch/>
        </p:blipFill>
        <p:spPr>
          <a:xfrm>
            <a:off x="0" y="1506584"/>
            <a:ext cx="9144000" cy="429868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20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4394199" y="2035165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4572000" y="2000240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4572000" y="171448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3429000"/>
            <a:ext cx="850112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342900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76_nogreenlineall.png"/>
          <p:cNvPicPr>
            <a:picLocks noChangeAspect="1"/>
          </p:cNvPicPr>
          <p:nvPr/>
        </p:nvPicPr>
        <p:blipFill rotWithShape="1">
          <a:blip r:embed="rId2"/>
          <a:srcRect t="14246" r="7219" b="28975"/>
          <a:stretch/>
        </p:blipFill>
        <p:spPr>
          <a:xfrm>
            <a:off x="0" y="1700808"/>
            <a:ext cx="9144000" cy="3893935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5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5965835" y="224947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6143636" y="221455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6143636" y="192880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3643314"/>
            <a:ext cx="8429684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364331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186_nogreenlineall.png"/>
          <p:cNvPicPr>
            <a:picLocks noChangeAspect="1"/>
          </p:cNvPicPr>
          <p:nvPr/>
        </p:nvPicPr>
        <p:blipFill rotWithShape="1">
          <a:blip r:embed="rId2"/>
          <a:srcRect t="13837" r="7219" b="28568"/>
          <a:stretch/>
        </p:blipFill>
        <p:spPr>
          <a:xfrm>
            <a:off x="0" y="1484784"/>
            <a:ext cx="9144000" cy="3949761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3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3536943" y="2035165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3714744" y="2000240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3714744" y="171448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928794" y="3429000"/>
            <a:ext cx="71438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928794" y="342900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 descr="zcvg150_nogreenlineall.png"/>
          <p:cNvPicPr>
            <a:picLocks noChangeAspect="1"/>
          </p:cNvPicPr>
          <p:nvPr/>
        </p:nvPicPr>
        <p:blipFill rotWithShape="1">
          <a:blip r:embed="rId2"/>
          <a:srcRect t="13839" r="7399" b="11473"/>
          <a:stretch/>
        </p:blipFill>
        <p:spPr>
          <a:xfrm>
            <a:off x="0" y="1196752"/>
            <a:ext cx="9144000" cy="512213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8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5322893" y="1820851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5500694" y="1785926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5500694" y="150017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3214686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321468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928794" y="3214686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928794" y="321468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3714744" y="3214686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714744" y="321468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5500694" y="3214686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500694" y="321468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7286644" y="3214686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7286644" y="321468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66_nogreenlineall.png"/>
          <p:cNvPicPr>
            <a:picLocks noChangeAspect="1"/>
          </p:cNvPicPr>
          <p:nvPr/>
        </p:nvPicPr>
        <p:blipFill rotWithShape="1">
          <a:blip r:embed="rId2"/>
          <a:srcRect t="14042" r="7039" b="28771"/>
          <a:stretch/>
        </p:blipFill>
        <p:spPr>
          <a:xfrm>
            <a:off x="0" y="1595384"/>
            <a:ext cx="9144000" cy="3921848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8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5965835" y="2463793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6143636" y="2428868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6143636" y="214311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3929066"/>
            <a:ext cx="750099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392906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 descr="zcvg166_nogreenlineall.png"/>
          <p:cNvPicPr>
            <a:picLocks noChangeAspect="1"/>
          </p:cNvPicPr>
          <p:nvPr/>
        </p:nvPicPr>
        <p:blipFill rotWithShape="1">
          <a:blip r:embed="rId2"/>
          <a:srcRect l="-7179" t="13839" r="7179" b="11473"/>
          <a:stretch/>
        </p:blipFill>
        <p:spPr>
          <a:xfrm>
            <a:off x="-612576" y="1259198"/>
            <a:ext cx="9721080" cy="5122130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9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5322893" y="3392487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5500694" y="3357562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5500694" y="307181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928794" y="4429132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857356" y="442913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3714744" y="4429132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643306" y="442913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6357950" y="4429132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286512" y="442913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5500694" y="4786322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429256" y="478632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正方形/長方形 15"/>
          <p:cNvSpPr/>
          <p:nvPr/>
        </p:nvSpPr>
        <p:spPr>
          <a:xfrm>
            <a:off x="3714744" y="4786322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643306" y="478632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>
            <a:off x="1928794" y="4786322"/>
            <a:ext cx="10001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1857356" y="478632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 descr="zcvg69_nogreenlineall.png"/>
          <p:cNvPicPr>
            <a:picLocks noChangeAspect="1"/>
          </p:cNvPicPr>
          <p:nvPr/>
        </p:nvPicPr>
        <p:blipFill rotWithShape="1">
          <a:blip r:embed="rId2"/>
          <a:srcRect t="13839" r="7219" b="28568"/>
          <a:stretch/>
        </p:blipFill>
        <p:spPr>
          <a:xfrm>
            <a:off x="0" y="1351445"/>
            <a:ext cx="9144000" cy="3949763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9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9" name="直線コネクタ 8"/>
          <p:cNvCxnSpPr/>
          <p:nvPr/>
        </p:nvCxnSpPr>
        <p:spPr>
          <a:xfrm rot="5400000">
            <a:off x="6180149" y="189228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矢印コネクタ 9"/>
          <p:cNvCxnSpPr/>
          <p:nvPr/>
        </p:nvCxnSpPr>
        <p:spPr>
          <a:xfrm>
            <a:off x="6357950" y="185736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/>
          <p:cNvSpPr txBox="1"/>
          <p:nvPr/>
        </p:nvSpPr>
        <p:spPr>
          <a:xfrm>
            <a:off x="6357950" y="157161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42844" y="3286124"/>
            <a:ext cx="442915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42844" y="328612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 descr="zcvg168_nogreenlineall.png"/>
          <p:cNvPicPr>
            <a:picLocks noChangeAspect="1"/>
          </p:cNvPicPr>
          <p:nvPr/>
        </p:nvPicPr>
        <p:blipFill rotWithShape="1">
          <a:blip r:embed="rId2"/>
          <a:srcRect t="14448" r="7039" b="28930"/>
          <a:stretch/>
        </p:blipFill>
        <p:spPr>
          <a:xfrm>
            <a:off x="23636" y="1427298"/>
            <a:ext cx="9120364" cy="3883051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29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5322893" y="2320917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5500694" y="2285992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5500694" y="200024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4500570"/>
            <a:ext cx="928694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1406" y="450057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928794" y="4500570"/>
            <a:ext cx="178595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857356" y="450057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4572000" y="4500570"/>
            <a:ext cx="928694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500562" y="450057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6357950" y="4500570"/>
            <a:ext cx="928694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286512" y="450057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187_nogreenlineall.png"/>
          <p:cNvPicPr>
            <a:picLocks noChangeAspect="1"/>
          </p:cNvPicPr>
          <p:nvPr/>
        </p:nvPicPr>
        <p:blipFill rotWithShape="1">
          <a:blip r:embed="rId2"/>
          <a:srcRect t="13888" r="7093" b="28669"/>
          <a:stretch/>
        </p:blipFill>
        <p:spPr>
          <a:xfrm>
            <a:off x="0" y="1340768"/>
            <a:ext cx="9144000" cy="3939472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4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4394199" y="1963727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4572000" y="1928802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4572000" y="164305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3714752"/>
            <a:ext cx="621510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371475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図 13" descr="zcvg125_nogreenlineall.png"/>
          <p:cNvPicPr>
            <a:picLocks noChangeAspect="1"/>
          </p:cNvPicPr>
          <p:nvPr/>
        </p:nvPicPr>
        <p:blipFill rotWithShape="1">
          <a:blip r:embed="rId2"/>
          <a:srcRect t="14141" r="7025" b="17276"/>
          <a:stretch/>
        </p:blipFill>
        <p:spPr>
          <a:xfrm>
            <a:off x="-14431" y="1585652"/>
            <a:ext cx="9144000" cy="4703427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28596" y="274638"/>
            <a:ext cx="8229600" cy="1143000"/>
          </a:xfrm>
        </p:spPr>
        <p:txBody>
          <a:bodyPr>
            <a:normAutofit/>
          </a:bodyPr>
          <a:lstStyle/>
          <a:p>
            <a:r>
              <a:rPr kumimoji="1" lang="en-US" altLang="ja-JP" sz="2800" b="1" dirty="0"/>
              <a:t>Fish </a:t>
            </a:r>
            <a:r>
              <a:rPr kumimoji="1" lang="en-US" altLang="ja-JP" sz="2800" b="1" dirty="0" smtClean="0"/>
              <a:t>3</a:t>
            </a:r>
            <a:r>
              <a:rPr kumimoji="1" lang="en-US" altLang="ja-JP" sz="2800" b="1" dirty="0" smtClean="0"/>
              <a:t> </a:t>
            </a:r>
            <a:r>
              <a:rPr kumimoji="1" lang="en-US" altLang="ja-JP" sz="2800" b="1" dirty="0"/>
              <a:t>with both ensembles</a:t>
            </a:r>
            <a:endParaRPr kumimoji="1" lang="ja-JP" altLang="en-US" sz="2800" b="1" dirty="0"/>
          </a:p>
        </p:txBody>
      </p:sp>
      <p:cxnSp>
        <p:nvCxnSpPr>
          <p:cNvPr id="6" name="直線コネクタ 5"/>
          <p:cNvCxnSpPr/>
          <p:nvPr/>
        </p:nvCxnSpPr>
        <p:spPr>
          <a:xfrm rot="5400000">
            <a:off x="6180149" y="2535231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/>
          <p:cNvCxnSpPr/>
          <p:nvPr/>
        </p:nvCxnSpPr>
        <p:spPr>
          <a:xfrm>
            <a:off x="6357950" y="2500306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6357950" y="221455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42844" y="3571876"/>
            <a:ext cx="800105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2844" y="3549851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Auto</a:t>
            </a:r>
            <a:r>
              <a:rPr lang="ja-JP" altLang="ja-JP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altLang="ja-JP" sz="1400" b="1" dirty="0">
                <a:latin typeface="Arial" pitchFamily="34" charset="0"/>
                <a:cs typeface="Arial" pitchFamily="34" charset="0"/>
              </a:rPr>
              <a:t>M</a:t>
            </a:r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v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42844" y="5143512"/>
            <a:ext cx="892975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42844" y="514351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181_nogreenlineall.png"/>
          <p:cNvPicPr>
            <a:picLocks noChangeAspect="1"/>
          </p:cNvPicPr>
          <p:nvPr/>
        </p:nvPicPr>
        <p:blipFill rotWithShape="1">
          <a:blip r:embed="rId2"/>
          <a:srcRect t="13889" r="7279" b="5944"/>
          <a:stretch/>
        </p:blipFill>
        <p:spPr>
          <a:xfrm>
            <a:off x="16172" y="1340768"/>
            <a:ext cx="9127827" cy="5497944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2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6180149" y="189228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6357950" y="185736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6357950" y="157161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44" y="3714752"/>
            <a:ext cx="442915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371475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 descr="zcvg139_nogreenlineall.png"/>
          <p:cNvPicPr>
            <a:picLocks noChangeAspect="1"/>
          </p:cNvPicPr>
          <p:nvPr/>
        </p:nvPicPr>
        <p:blipFill rotWithShape="1">
          <a:blip r:embed="rId2"/>
          <a:srcRect t="13888" r="7093" b="40144"/>
          <a:stretch/>
        </p:blipFill>
        <p:spPr>
          <a:xfrm>
            <a:off x="17358" y="1347450"/>
            <a:ext cx="9126641" cy="3152471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7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6180149" y="224947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6357950" y="221455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6357950" y="192880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928794" y="3714752"/>
            <a:ext cx="107157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928794" y="371475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正方形/長方形 14"/>
          <p:cNvSpPr/>
          <p:nvPr/>
        </p:nvSpPr>
        <p:spPr>
          <a:xfrm>
            <a:off x="3714744" y="3714752"/>
            <a:ext cx="107157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3714744" y="371475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正方形/長方形 16"/>
          <p:cNvSpPr/>
          <p:nvPr/>
        </p:nvSpPr>
        <p:spPr>
          <a:xfrm>
            <a:off x="8143900" y="3714752"/>
            <a:ext cx="10001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8072462" y="371475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 descr="zcvg129_nogreenlineall.png"/>
          <p:cNvPicPr>
            <a:picLocks noChangeAspect="1"/>
          </p:cNvPicPr>
          <p:nvPr/>
        </p:nvPicPr>
        <p:blipFill rotWithShape="1">
          <a:blip r:embed="rId2"/>
          <a:srcRect t="14099" r="7093" b="11817"/>
          <a:stretch/>
        </p:blipFill>
        <p:spPr>
          <a:xfrm>
            <a:off x="0" y="1340768"/>
            <a:ext cx="9144000" cy="5080715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0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7" name="直線コネクタ 6"/>
          <p:cNvCxnSpPr/>
          <p:nvPr/>
        </p:nvCxnSpPr>
        <p:spPr>
          <a:xfrm rot="5400000">
            <a:off x="5322893" y="224947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矢印コネクタ 7"/>
          <p:cNvCxnSpPr/>
          <p:nvPr/>
        </p:nvCxnSpPr>
        <p:spPr>
          <a:xfrm>
            <a:off x="5500694" y="221455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/>
          <p:cNvSpPr txBox="1"/>
          <p:nvPr/>
        </p:nvSpPr>
        <p:spPr>
          <a:xfrm>
            <a:off x="5500694" y="192880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928794" y="4500570"/>
            <a:ext cx="71438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928794" y="450057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1071538" y="3308149"/>
            <a:ext cx="800105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071538" y="328612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Auto</a:t>
            </a:r>
            <a:r>
              <a:rPr kumimoji="1" lang="ja-JP" altLang="en-US" sz="1400" b="1" dirty="0">
                <a:latin typeface="Arial" pitchFamily="34" charset="0"/>
                <a:cs typeface="Arial" pitchFamily="34" charset="0"/>
              </a:rPr>
              <a:t> </a:t>
            </a:r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Mov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142844" y="3714752"/>
            <a:ext cx="4500594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42844" y="3692727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Auto mov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111_nogreenlineall.png"/>
          <p:cNvPicPr>
            <a:picLocks noChangeAspect="1"/>
          </p:cNvPicPr>
          <p:nvPr/>
        </p:nvPicPr>
        <p:blipFill rotWithShape="1">
          <a:blip r:embed="rId2"/>
          <a:srcRect t="13687" r="7093" b="28238"/>
          <a:stretch/>
        </p:blipFill>
        <p:spPr>
          <a:xfrm>
            <a:off x="17062" y="1340768"/>
            <a:ext cx="9126938" cy="3982764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6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2608249" y="1963727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2786050" y="1928802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2786050" y="164305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857488" y="4929198"/>
            <a:ext cx="585791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857488" y="492919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zcvg202_nogreenlineall.png"/>
          <p:cNvPicPr>
            <a:picLocks noChangeAspect="1"/>
          </p:cNvPicPr>
          <p:nvPr/>
        </p:nvPicPr>
        <p:blipFill rotWithShape="1">
          <a:blip r:embed="rId2"/>
          <a:srcRect t="13888" r="7093" b="34771"/>
          <a:stretch/>
        </p:blipFill>
        <p:spPr>
          <a:xfrm>
            <a:off x="0" y="2039387"/>
            <a:ext cx="9144000" cy="3520993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21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-34957" y="296385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142844" y="292893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142844" y="264318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4429124" y="4000504"/>
            <a:ext cx="464347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429124" y="400050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42844" y="4429132"/>
            <a:ext cx="335758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2844" y="442913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 descr="zcvg151_nogreenlineall.png"/>
          <p:cNvPicPr>
            <a:picLocks noChangeAspect="1"/>
          </p:cNvPicPr>
          <p:nvPr/>
        </p:nvPicPr>
        <p:blipFill rotWithShape="1">
          <a:blip r:embed="rId2"/>
          <a:srcRect t="14308" r="7093" b="28669"/>
          <a:stretch/>
        </p:blipFill>
        <p:spPr>
          <a:xfrm>
            <a:off x="36512" y="1534612"/>
            <a:ext cx="9144000" cy="3910612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46856" y="274638"/>
            <a:ext cx="8229600" cy="1143000"/>
          </a:xfrm>
        </p:spPr>
        <p:txBody>
          <a:bodyPr>
            <a:normAutofit/>
          </a:bodyPr>
          <a:lstStyle/>
          <a:p>
            <a:r>
              <a:rPr kumimoji="1" lang="en-US" altLang="ja-JP" sz="2800" b="1" dirty="0"/>
              <a:t>Fish 11 with only </a:t>
            </a:r>
            <a:r>
              <a:rPr lang="en-US" altLang="ja-JP" sz="2800" b="1" dirty="0"/>
              <a:t>color-rule ensemble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4394199" y="2463793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4572000" y="2428868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4572000" y="214311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7286644" y="3500438"/>
            <a:ext cx="10001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215206" y="350043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4572000" y="3500438"/>
            <a:ext cx="10001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4500562" y="350043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2857488" y="3500438"/>
            <a:ext cx="10001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786050" y="350043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正方形/長方形 13"/>
          <p:cNvSpPr/>
          <p:nvPr/>
        </p:nvSpPr>
        <p:spPr>
          <a:xfrm>
            <a:off x="1071538" y="3500438"/>
            <a:ext cx="10001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000100" y="350043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zcvg90_nogreenlineall.png"/>
          <p:cNvPicPr>
            <a:picLocks noChangeAspect="1"/>
          </p:cNvPicPr>
          <p:nvPr/>
        </p:nvPicPr>
        <p:blipFill rotWithShape="1">
          <a:blip r:embed="rId2"/>
          <a:srcRect t="13839" r="7399" b="6792"/>
          <a:stretch/>
        </p:blipFill>
        <p:spPr>
          <a:xfrm>
            <a:off x="150650" y="1312050"/>
            <a:ext cx="8964488" cy="5443135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</a:t>
            </a:r>
            <a:r>
              <a:rPr kumimoji="1" lang="en-US" altLang="ja-JP" sz="2800" b="1" dirty="0" smtClean="0"/>
              <a:t>2</a:t>
            </a:r>
            <a:r>
              <a:rPr kumimoji="1" lang="en-US" altLang="ja-JP" sz="2800" b="1" dirty="0" smtClean="0"/>
              <a:t> </a:t>
            </a:r>
            <a:r>
              <a:rPr kumimoji="1" lang="en-US" altLang="ja-JP" sz="2800" b="1" dirty="0"/>
              <a:t>with both ensembles</a:t>
            </a:r>
            <a:endParaRPr kumimoji="1" lang="ja-JP" altLang="en-US" sz="2800" b="1" dirty="0"/>
          </a:p>
        </p:txBody>
      </p:sp>
      <p:cxnSp>
        <p:nvCxnSpPr>
          <p:cNvPr id="4" name="直線コネクタ 3"/>
          <p:cNvCxnSpPr/>
          <p:nvPr/>
        </p:nvCxnSpPr>
        <p:spPr>
          <a:xfrm rot="5400000">
            <a:off x="3608381" y="189228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3786182" y="185736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3786182" y="157161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214250" y="3714752"/>
            <a:ext cx="450062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14250" y="371475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3786150" y="3286124"/>
            <a:ext cx="5286444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786182" y="328612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 descr="zcvg209_nogreenlineall.png"/>
          <p:cNvPicPr>
            <a:picLocks noChangeAspect="1"/>
          </p:cNvPicPr>
          <p:nvPr/>
        </p:nvPicPr>
        <p:blipFill rotWithShape="1">
          <a:blip r:embed="rId2"/>
          <a:srcRect t="14042" r="7399" b="46070"/>
          <a:stretch/>
        </p:blipFill>
        <p:spPr>
          <a:xfrm>
            <a:off x="0" y="1556395"/>
            <a:ext cx="9108504" cy="3168749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4 with both ensembles</a:t>
            </a:r>
            <a:endParaRPr kumimoji="1" lang="ja-JP" altLang="en-US" sz="2800" b="1" dirty="0"/>
          </a:p>
        </p:txBody>
      </p:sp>
      <p:cxnSp>
        <p:nvCxnSpPr>
          <p:cNvPr id="6" name="直線コネクタ 5"/>
          <p:cNvCxnSpPr/>
          <p:nvPr/>
        </p:nvCxnSpPr>
        <p:spPr>
          <a:xfrm rot="5400000">
            <a:off x="5322893" y="2741565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矢印コネクタ 6"/>
          <p:cNvCxnSpPr/>
          <p:nvPr/>
        </p:nvCxnSpPr>
        <p:spPr>
          <a:xfrm>
            <a:off x="5500694" y="2707332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5500694" y="242088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142812" y="3857628"/>
            <a:ext cx="628657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42844" y="385762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正方形/長方形 10"/>
          <p:cNvSpPr/>
          <p:nvPr/>
        </p:nvSpPr>
        <p:spPr>
          <a:xfrm>
            <a:off x="8143868" y="3429000"/>
            <a:ext cx="92872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072462" y="342900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g181_nogreenlineall.png"/>
          <p:cNvPicPr>
            <a:picLocks noChangeAspect="1"/>
          </p:cNvPicPr>
          <p:nvPr/>
        </p:nvPicPr>
        <p:blipFill rotWithShape="1">
          <a:blip r:embed="rId2"/>
          <a:srcRect t="13839" r="7039" b="28568"/>
          <a:stretch/>
        </p:blipFill>
        <p:spPr>
          <a:xfrm>
            <a:off x="0" y="1351445"/>
            <a:ext cx="9144001" cy="3949763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6 with both ensembles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-34957" y="3821115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142844" y="3786190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142844" y="350043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42812" y="4500570"/>
            <a:ext cx="892978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42844" y="450057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zcvg119_nogreenlineall.png"/>
          <p:cNvPicPr>
            <a:picLocks noChangeAspect="1"/>
          </p:cNvPicPr>
          <p:nvPr/>
        </p:nvPicPr>
        <p:blipFill rotWithShape="1">
          <a:blip r:embed="rId2"/>
          <a:srcRect t="13839" r="7219" b="5978"/>
          <a:stretch/>
        </p:blipFill>
        <p:spPr>
          <a:xfrm>
            <a:off x="5924" y="1332434"/>
            <a:ext cx="9138075" cy="5498962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28 with both ensembles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2608249" y="2678107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2786050" y="2643182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2786050" y="235743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5500662" y="5286388"/>
            <a:ext cx="35719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500694" y="528638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42844" y="5643578"/>
            <a:ext cx="357193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2876" y="564357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zcvg70_nogreenlineall.png"/>
          <p:cNvPicPr>
            <a:picLocks noChangeAspect="1"/>
          </p:cNvPicPr>
          <p:nvPr/>
        </p:nvPicPr>
        <p:blipFill rotWithShape="1">
          <a:blip r:embed="rId2"/>
          <a:srcRect t="14042" r="7039" b="17375"/>
          <a:stretch/>
        </p:blipFill>
        <p:spPr>
          <a:xfrm>
            <a:off x="0" y="1317862"/>
            <a:ext cx="9144000" cy="4703426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5 with both ensembles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5251455" y="1892289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5429256" y="1857364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5429256" y="157161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7858148" y="4071942"/>
            <a:ext cx="1214446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7858180" y="4071942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42844" y="4500570"/>
            <a:ext cx="4143404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2876" y="4500570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zcvg213_nogreenlineall.png"/>
          <p:cNvPicPr>
            <a:picLocks noChangeAspect="1"/>
          </p:cNvPicPr>
          <p:nvPr/>
        </p:nvPicPr>
        <p:blipFill rotWithShape="1">
          <a:blip r:embed="rId2"/>
          <a:srcRect t="14462" r="7184" b="45853"/>
          <a:stretch/>
        </p:blipFill>
        <p:spPr>
          <a:xfrm>
            <a:off x="0" y="1628800"/>
            <a:ext cx="9144000" cy="2721567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7 with both ensembles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-34957" y="2535231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142844" y="2500306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142844" y="2214554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5500694" y="3571876"/>
            <a:ext cx="3571900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500694" y="357187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42844" y="3929066"/>
            <a:ext cx="635798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2844" y="3929066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 descr="zcvg201_nogreenlineall.png"/>
          <p:cNvPicPr>
            <a:picLocks noChangeAspect="1"/>
          </p:cNvPicPr>
          <p:nvPr/>
        </p:nvPicPr>
        <p:blipFill rotWithShape="1">
          <a:blip r:embed="rId2"/>
          <a:srcRect t="14245" r="7219" b="5979"/>
          <a:stretch/>
        </p:blipFill>
        <p:spPr>
          <a:xfrm>
            <a:off x="0" y="1411119"/>
            <a:ext cx="9144000" cy="5471048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kumimoji="1" lang="en-US" altLang="ja-JP" sz="2800" b="1" dirty="0"/>
              <a:t>Fish 1 with both ensembles</a:t>
            </a:r>
            <a:endParaRPr kumimoji="1" lang="ja-JP" altLang="en-US" sz="2800" b="1" dirty="0"/>
          </a:p>
        </p:txBody>
      </p:sp>
      <p:cxnSp>
        <p:nvCxnSpPr>
          <p:cNvPr id="5" name="直線コネクタ 4"/>
          <p:cNvCxnSpPr/>
          <p:nvPr/>
        </p:nvCxnSpPr>
        <p:spPr>
          <a:xfrm rot="5400000">
            <a:off x="865807" y="3825675"/>
            <a:ext cx="357190" cy="158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矢印コネクタ 5"/>
          <p:cNvCxnSpPr/>
          <p:nvPr/>
        </p:nvCxnSpPr>
        <p:spPr>
          <a:xfrm>
            <a:off x="1043608" y="3790750"/>
            <a:ext cx="1000132" cy="1588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/>
          <p:cNvSpPr txBox="1"/>
          <p:nvPr/>
        </p:nvSpPr>
        <p:spPr>
          <a:xfrm>
            <a:off x="1043608" y="350100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Learner state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1969272" y="4941168"/>
            <a:ext cx="6357982" cy="3571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969272" y="4941168"/>
            <a:ext cx="13573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>
                <a:latin typeface="Arial" pitchFamily="34" charset="0"/>
                <a:cs typeface="Arial" pitchFamily="34" charset="0"/>
              </a:rPr>
              <a:t>Open-loop</a:t>
            </a:r>
            <a:endParaRPr kumimoji="1" lang="ja-JP" altLang="en-US" sz="14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636</TotalTime>
  <Words>365</Words>
  <Application>Microsoft Macintosh PowerPoint</Application>
  <PresentationFormat>画面に合わせる (4:3)</PresentationFormat>
  <Paragraphs>99</Paragraphs>
  <Slides>2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5</vt:i4>
      </vt:variant>
    </vt:vector>
  </HeadingPairs>
  <TitlesOfParts>
    <vt:vector size="26" baseType="lpstr">
      <vt:lpstr>Office テーマ</vt:lpstr>
      <vt:lpstr>Traveled Distance</vt:lpstr>
      <vt:lpstr>Fish 3 with both ensembles</vt:lpstr>
      <vt:lpstr>Fish 2 with both ensembles</vt:lpstr>
      <vt:lpstr>Fish 4 with both ensembles</vt:lpstr>
      <vt:lpstr>Fish 6 with both ensembles</vt:lpstr>
      <vt:lpstr>Fish 28 with both ensembles</vt:lpstr>
      <vt:lpstr>Fish 5 with both ensembles</vt:lpstr>
      <vt:lpstr>Fish 7 with both ensembles</vt:lpstr>
      <vt:lpstr>Fish 1 with both ensembles</vt:lpstr>
      <vt:lpstr>Fish 30 with only color-rule ensemble</vt:lpstr>
      <vt:lpstr>Fish 20 with only color-rule ensemble</vt:lpstr>
      <vt:lpstr>Fish 15 with only color-rule ensemble</vt:lpstr>
      <vt:lpstr>Fish 13 with only color-rule ensemble</vt:lpstr>
      <vt:lpstr>Fish 18 with only color-rule ensemble</vt:lpstr>
      <vt:lpstr>Fish 8 with only color-rule ensemble</vt:lpstr>
      <vt:lpstr>Fish 19 with only color-rule ensemble</vt:lpstr>
      <vt:lpstr>Fish 9 with only color-rule ensemble</vt:lpstr>
      <vt:lpstr>Fish 29 with only color-rule ensemble</vt:lpstr>
      <vt:lpstr>Fish 14 with only color-rule ensemble</vt:lpstr>
      <vt:lpstr>Fish 12 with only color-rule ensemble</vt:lpstr>
      <vt:lpstr>Fish 17 with only color-rule ensemble</vt:lpstr>
      <vt:lpstr>Fish 10 with only color-rule ensemble</vt:lpstr>
      <vt:lpstr>Fish 16 with only color-rule ensemble</vt:lpstr>
      <vt:lpstr>Fish 21 with only color-rule ensemble</vt:lpstr>
      <vt:lpstr>Fish 11 with only color-rule ensemble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aveled Distance</dc:title>
  <dc:creator>makio</dc:creator>
  <cp:lastModifiedBy>Makio Torigoe</cp:lastModifiedBy>
  <cp:revision>38</cp:revision>
  <dcterms:created xsi:type="dcterms:W3CDTF">2020-04-01T06:45:25Z</dcterms:created>
  <dcterms:modified xsi:type="dcterms:W3CDTF">2021-04-28T03:43:49Z</dcterms:modified>
</cp:coreProperties>
</file>